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7" d="100"/>
          <a:sy n="57" d="100"/>
        </p:scale>
        <p:origin x="-2726" y="-91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\9\17 Mon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0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. (A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dy weight changes in AOM/DSS-induced CRC model (n=15 for each group) during 25 weeks. Body weights were collected three times per week, and the data are presented as the mean ± SD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gan indexes of heart, liver, spleen, lung, kidney and thymus were detected after treatments with different concentrations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ogoni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each mouse (n=15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386" y="830997"/>
            <a:ext cx="6858000" cy="64990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086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</cp:lastModifiedBy>
  <cp:revision>1</cp:revision>
  <dcterms:created xsi:type="dcterms:W3CDTF">2018-09-17T06:26:41Z</dcterms:created>
  <dcterms:modified xsi:type="dcterms:W3CDTF">2018-09-17T06:29:53Z</dcterms:modified>
</cp:coreProperties>
</file>